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0" r:id="rId3"/>
    <p:sldId id="258" r:id="rId4"/>
    <p:sldId id="259" r:id="rId5"/>
    <p:sldId id="264" r:id="rId6"/>
    <p:sldId id="261" r:id="rId7"/>
    <p:sldId id="262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7884" autoAdjust="0"/>
    <p:restoredTop sz="94660"/>
  </p:normalViewPr>
  <p:slideViewPr>
    <p:cSldViewPr snapToGrid="0">
      <p:cViewPr>
        <p:scale>
          <a:sx n="119" d="100"/>
          <a:sy n="119" d="100"/>
        </p:scale>
        <p:origin x="1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287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87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200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604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489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831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194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019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518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317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56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D8385-0FF8-41CC-B42F-176F5ED01673}" type="datetimeFigureOut">
              <a:rPr lang="en-US" smtClean="0"/>
              <a:t>2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39723-4733-4263-9824-F1811EF22A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50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3.emf"/><Relationship Id="rId21" Type="http://schemas.openxmlformats.org/officeDocument/2006/relationships/image" Target="../media/image12.emf"/><Relationship Id="rId7" Type="http://schemas.openxmlformats.org/officeDocument/2006/relationships/image" Target="../media/image5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5" Type="http://schemas.openxmlformats.org/officeDocument/2006/relationships/image" Target="../media/image9.emf"/><Relationship Id="rId23" Type="http://schemas.openxmlformats.org/officeDocument/2006/relationships/image" Target="../media/image13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11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DB256A0-6DE9-A0D5-6C93-99F19CF6E8B4}"/>
              </a:ext>
            </a:extLst>
          </p:cNvPr>
          <p:cNvGraphicFramePr>
            <a:graphicFrameLocks noGrp="1"/>
          </p:cNvGraphicFramePr>
          <p:nvPr/>
        </p:nvGraphicFramePr>
        <p:xfrm>
          <a:off x="130723" y="1138238"/>
          <a:ext cx="6596554" cy="4631805"/>
        </p:xfrm>
        <a:graphic>
          <a:graphicData uri="http://schemas.openxmlformats.org/drawingml/2006/table">
            <a:tbl>
              <a:tblPr firstRow="1" firstCol="1" bandRow="1"/>
              <a:tblGrid>
                <a:gridCol w="663838">
                  <a:extLst>
                    <a:ext uri="{9D8B030D-6E8A-4147-A177-3AD203B41FA5}">
                      <a16:colId xmlns:a16="http://schemas.microsoft.com/office/drawing/2014/main" val="528907458"/>
                    </a:ext>
                  </a:extLst>
                </a:gridCol>
                <a:gridCol w="368733">
                  <a:extLst>
                    <a:ext uri="{9D8B030D-6E8A-4147-A177-3AD203B41FA5}">
                      <a16:colId xmlns:a16="http://schemas.microsoft.com/office/drawing/2014/main" val="3612556917"/>
                    </a:ext>
                  </a:extLst>
                </a:gridCol>
                <a:gridCol w="1193966">
                  <a:extLst>
                    <a:ext uri="{9D8B030D-6E8A-4147-A177-3AD203B41FA5}">
                      <a16:colId xmlns:a16="http://schemas.microsoft.com/office/drawing/2014/main" val="1906960184"/>
                    </a:ext>
                  </a:extLst>
                </a:gridCol>
                <a:gridCol w="1205746">
                  <a:extLst>
                    <a:ext uri="{9D8B030D-6E8A-4147-A177-3AD203B41FA5}">
                      <a16:colId xmlns:a16="http://schemas.microsoft.com/office/drawing/2014/main" val="1884758252"/>
                    </a:ext>
                  </a:extLst>
                </a:gridCol>
                <a:gridCol w="495375">
                  <a:extLst>
                    <a:ext uri="{9D8B030D-6E8A-4147-A177-3AD203B41FA5}">
                      <a16:colId xmlns:a16="http://schemas.microsoft.com/office/drawing/2014/main" val="517416972"/>
                    </a:ext>
                  </a:extLst>
                </a:gridCol>
                <a:gridCol w="507156">
                  <a:extLst>
                    <a:ext uri="{9D8B030D-6E8A-4147-A177-3AD203B41FA5}">
                      <a16:colId xmlns:a16="http://schemas.microsoft.com/office/drawing/2014/main" val="1047676381"/>
                    </a:ext>
                  </a:extLst>
                </a:gridCol>
                <a:gridCol w="577249">
                  <a:extLst>
                    <a:ext uri="{9D8B030D-6E8A-4147-A177-3AD203B41FA5}">
                      <a16:colId xmlns:a16="http://schemas.microsoft.com/office/drawing/2014/main" val="2432933418"/>
                    </a:ext>
                  </a:extLst>
                </a:gridCol>
                <a:gridCol w="518347">
                  <a:extLst>
                    <a:ext uri="{9D8B030D-6E8A-4147-A177-3AD203B41FA5}">
                      <a16:colId xmlns:a16="http://schemas.microsoft.com/office/drawing/2014/main" val="2601596482"/>
                    </a:ext>
                  </a:extLst>
                </a:gridCol>
                <a:gridCol w="577249">
                  <a:extLst>
                    <a:ext uri="{9D8B030D-6E8A-4147-A177-3AD203B41FA5}">
                      <a16:colId xmlns:a16="http://schemas.microsoft.com/office/drawing/2014/main" val="2004021088"/>
                    </a:ext>
                  </a:extLst>
                </a:gridCol>
                <a:gridCol w="488895">
                  <a:extLst>
                    <a:ext uri="{9D8B030D-6E8A-4147-A177-3AD203B41FA5}">
                      <a16:colId xmlns:a16="http://schemas.microsoft.com/office/drawing/2014/main" val="2689874500"/>
                    </a:ext>
                  </a:extLst>
                </a:gridCol>
              </a:tblGrid>
              <a:tr h="175001">
                <a:tc gridSpan="10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high confidence candidate neoantigens in KP2-OXPARPi Clone E:  MHCI: 15, MHCII: 9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5287990"/>
                  </a:ext>
                </a:extLst>
              </a:tr>
              <a:tr h="25678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HC 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T Epitope Sequenc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 Epitope Sequenc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T Scor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 Scor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NA Depth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DNA VA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NA Depth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NA VA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2789190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zh2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9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I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FDYRYSQADALKY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FDYRYSQADALKY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9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1658566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p10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GIHT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FPPTVKKI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GIHT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FPPTVKKI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8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0126828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ep295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VDQPTVAP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SG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VDQPTVAP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SGR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84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0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9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7298190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m6sf1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YNQPSENYNYPSKVLQ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YNQPSENYNYPSKVLQ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2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0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9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839856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dhc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SLPMALSVCHRGSGK</a:t>
                      </a:r>
                    </a:p>
                  </a:txBody>
                  <a:tcPr marL="9525" marR="9525" marT="95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SLPMALSVCHRGSGK</a:t>
                      </a:r>
                    </a:p>
                  </a:txBody>
                  <a:tcPr marL="9525" marR="9525" marT="95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</a:t>
                      </a:r>
                    </a:p>
                  </a:txBody>
                  <a:tcPr marL="9525" marR="9525" marT="95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</a:t>
                      </a:r>
                    </a:p>
                  </a:txBody>
                  <a:tcPr marL="9525" marR="9525" marT="95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9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6694346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 lvl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lr1b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KQFLGYVPIMVKSK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KQFLGYVPIMVKSK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9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4.3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823897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 lvl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box5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QD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HAPALPM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QD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HAPALPM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69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69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8212156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 lvl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Lc9a3r2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VESSAVRP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GPVF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VESSAVRP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GPVFS</a:t>
                      </a:r>
                    </a:p>
                  </a:txBody>
                  <a:tcPr marL="9525" marR="9525" marT="95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9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637149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 lvl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pb1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YAKAVKSHSSGTVS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YAKAVKSHSSGTVS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6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0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5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2510085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e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IKNVNTA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IKNVNT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2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1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348269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hdc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FSTHT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FSTHT</a:t>
                      </a:r>
                      <a:r>
                        <a:rPr lang="en-US" sz="700" b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3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8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4436203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d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VAQYVV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VAQYVV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18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1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7676273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ffb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NWEY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SLL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NWEY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SL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5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501041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drf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MALFLDK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MALFLDK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23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4964820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lb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QMF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V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QMF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V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7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2872034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bp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SFA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PN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SFA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PNE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7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7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2174366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btk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D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QK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D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QK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7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1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7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206223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lc15a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MFDA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I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MFDA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IL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7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2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4801262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m6sf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GLGWL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GLGWL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4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146485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xndc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FV</a:t>
                      </a:r>
                      <a:r>
                        <a:rPr lang="en-US" sz="7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YAPW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FV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YAPW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20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521676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Zfp69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NFGAHQR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NFGAHQR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26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6091265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t-Nd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YFLFY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YFLFY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37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2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56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4578825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rnl1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HAN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HAN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8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0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4543047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mp2k</a:t>
                      </a: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FE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FE</a:t>
                      </a:r>
                      <a:r>
                        <a:rPr lang="en-US" sz="700" b="0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1.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362.2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7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7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9020692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A812AFC-CBBB-82A7-03A6-0850B275E42E}"/>
              </a:ext>
            </a:extLst>
          </p:cNvPr>
          <p:cNvSpPr txBox="1"/>
          <p:nvPr/>
        </p:nvSpPr>
        <p:spPr>
          <a:xfrm>
            <a:off x="0" y="72509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. Table 1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7260282"/>
              </p:ext>
            </p:extLst>
          </p:nvPr>
        </p:nvGraphicFramePr>
        <p:xfrm>
          <a:off x="130723" y="6163049"/>
          <a:ext cx="6596554" cy="606782"/>
        </p:xfrm>
        <a:graphic>
          <a:graphicData uri="http://schemas.openxmlformats.org/drawingml/2006/table">
            <a:tbl>
              <a:tblPr firstRow="1" firstCol="1" bandRow="1"/>
              <a:tblGrid>
                <a:gridCol w="663838">
                  <a:extLst>
                    <a:ext uri="{9D8B030D-6E8A-4147-A177-3AD203B41FA5}">
                      <a16:colId xmlns:a16="http://schemas.microsoft.com/office/drawing/2014/main" val="3206320468"/>
                    </a:ext>
                  </a:extLst>
                </a:gridCol>
                <a:gridCol w="368733">
                  <a:extLst>
                    <a:ext uri="{9D8B030D-6E8A-4147-A177-3AD203B41FA5}">
                      <a16:colId xmlns:a16="http://schemas.microsoft.com/office/drawing/2014/main" val="2209328329"/>
                    </a:ext>
                  </a:extLst>
                </a:gridCol>
                <a:gridCol w="1193966">
                  <a:extLst>
                    <a:ext uri="{9D8B030D-6E8A-4147-A177-3AD203B41FA5}">
                      <a16:colId xmlns:a16="http://schemas.microsoft.com/office/drawing/2014/main" val="451309970"/>
                    </a:ext>
                  </a:extLst>
                </a:gridCol>
                <a:gridCol w="1205746">
                  <a:extLst>
                    <a:ext uri="{9D8B030D-6E8A-4147-A177-3AD203B41FA5}">
                      <a16:colId xmlns:a16="http://schemas.microsoft.com/office/drawing/2014/main" val="3658372885"/>
                    </a:ext>
                  </a:extLst>
                </a:gridCol>
                <a:gridCol w="495375">
                  <a:extLst>
                    <a:ext uri="{9D8B030D-6E8A-4147-A177-3AD203B41FA5}">
                      <a16:colId xmlns:a16="http://schemas.microsoft.com/office/drawing/2014/main" val="788740432"/>
                    </a:ext>
                  </a:extLst>
                </a:gridCol>
                <a:gridCol w="507156">
                  <a:extLst>
                    <a:ext uri="{9D8B030D-6E8A-4147-A177-3AD203B41FA5}">
                      <a16:colId xmlns:a16="http://schemas.microsoft.com/office/drawing/2014/main" val="1293649310"/>
                    </a:ext>
                  </a:extLst>
                </a:gridCol>
                <a:gridCol w="577249">
                  <a:extLst>
                    <a:ext uri="{9D8B030D-6E8A-4147-A177-3AD203B41FA5}">
                      <a16:colId xmlns:a16="http://schemas.microsoft.com/office/drawing/2014/main" val="1740195567"/>
                    </a:ext>
                  </a:extLst>
                </a:gridCol>
                <a:gridCol w="518347">
                  <a:extLst>
                    <a:ext uri="{9D8B030D-6E8A-4147-A177-3AD203B41FA5}">
                      <a16:colId xmlns:a16="http://schemas.microsoft.com/office/drawing/2014/main" val="2057040919"/>
                    </a:ext>
                  </a:extLst>
                </a:gridCol>
                <a:gridCol w="577249">
                  <a:extLst>
                    <a:ext uri="{9D8B030D-6E8A-4147-A177-3AD203B41FA5}">
                      <a16:colId xmlns:a16="http://schemas.microsoft.com/office/drawing/2014/main" val="1372385939"/>
                    </a:ext>
                  </a:extLst>
                </a:gridCol>
                <a:gridCol w="488895">
                  <a:extLst>
                    <a:ext uri="{9D8B030D-6E8A-4147-A177-3AD203B41FA5}">
                      <a16:colId xmlns:a16="http://schemas.microsoft.com/office/drawing/2014/main" val="4249204868"/>
                    </a:ext>
                  </a:extLst>
                </a:gridCol>
              </a:tblGrid>
              <a:tr h="175001">
                <a:tc gridSpan="10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high confidence candidate neoantigens in KP2:    MHCI: 0, MHCII: 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6939007"/>
                  </a:ext>
                </a:extLst>
              </a:tr>
              <a:tr h="25678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HC 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T Epitope Sequenc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 Epitope Sequenc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T Scor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 Scor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NA Depth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DNA VA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NA Depth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NA VA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341375"/>
                  </a:ext>
                </a:extLst>
              </a:tr>
              <a:tr h="17500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SZ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KPPLAPSS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PP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KPPLAPSS</a:t>
                      </a:r>
                      <a:r>
                        <a:rPr lang="en-US" sz="700" b="1" u="sng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PP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9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2.8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3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558" marR="4155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26542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85985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617855" y="628643"/>
          <a:ext cx="5565140" cy="4972050"/>
        </p:xfrm>
        <a:graphic>
          <a:graphicData uri="http://schemas.openxmlformats.org/drawingml/2006/table">
            <a:tbl>
              <a:tblPr firstRow="1" firstCol="1" bandRow="1"/>
              <a:tblGrid>
                <a:gridCol w="782320">
                  <a:extLst>
                    <a:ext uri="{9D8B030D-6E8A-4147-A177-3AD203B41FA5}">
                      <a16:colId xmlns:a16="http://schemas.microsoft.com/office/drawing/2014/main" val="1952601949"/>
                    </a:ext>
                  </a:extLst>
                </a:gridCol>
                <a:gridCol w="823595">
                  <a:extLst>
                    <a:ext uri="{9D8B030D-6E8A-4147-A177-3AD203B41FA5}">
                      <a16:colId xmlns:a16="http://schemas.microsoft.com/office/drawing/2014/main" val="4014904529"/>
                    </a:ext>
                  </a:extLst>
                </a:gridCol>
                <a:gridCol w="910590">
                  <a:extLst>
                    <a:ext uri="{9D8B030D-6E8A-4147-A177-3AD203B41FA5}">
                      <a16:colId xmlns:a16="http://schemas.microsoft.com/office/drawing/2014/main" val="2504675819"/>
                    </a:ext>
                  </a:extLst>
                </a:gridCol>
                <a:gridCol w="823595">
                  <a:extLst>
                    <a:ext uri="{9D8B030D-6E8A-4147-A177-3AD203B41FA5}">
                      <a16:colId xmlns:a16="http://schemas.microsoft.com/office/drawing/2014/main" val="4087312963"/>
                    </a:ext>
                  </a:extLst>
                </a:gridCol>
                <a:gridCol w="910590">
                  <a:extLst>
                    <a:ext uri="{9D8B030D-6E8A-4147-A177-3AD203B41FA5}">
                      <a16:colId xmlns:a16="http://schemas.microsoft.com/office/drawing/2014/main" val="4004364645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1033429384"/>
                    </a:ext>
                  </a:extLst>
                </a:gridCol>
              </a:tblGrid>
              <a:tr h="1663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lone 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lone 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lone 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P2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69244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45.64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999.59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C97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34.54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6D17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26.08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lass I/I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925973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K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943.63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75.01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A67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29.14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C67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8.85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4092996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D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441.49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38.1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AF7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48.97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CB7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66.92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20783312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Q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5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14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D4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6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4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8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444738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T2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1.82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947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4.19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4.48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86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C2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965576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r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.33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.75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93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.19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A8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7038271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d1d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7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C67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4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0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A8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.22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2512855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A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2.19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38.25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4.20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97.34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A83"/>
                    </a:solidFill>
                  </a:tcPr>
                </a:tc>
                <a:tc rowSpan="8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lass II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629399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A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0.4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E98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41.5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7.52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20.35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5951393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E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3.95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98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4.7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2.28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7.21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970185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M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3.04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6.09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C77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.2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D07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.1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96136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O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1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2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75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75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9100601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DM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.69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28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6.42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4.9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.73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48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0959984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DM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7.48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937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4.33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4.38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4.87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C87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335610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2-DMb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.25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.49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77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.53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E8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.92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8783118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d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2.21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9.0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887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0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.83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8D67F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cepto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9165548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d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7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C27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0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1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11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B8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5111725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cer1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0.07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1.00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AF7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.65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3.31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CE7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499536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cgr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.67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.25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AA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.2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.0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C67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4507535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cgr2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4.44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827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8.81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3.61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6.9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08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3338330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cgr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9.71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06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1.08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2.78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5.24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D67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897093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smb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62.55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2.63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ED3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7.08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7CC57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.7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oteosom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1689952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smb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8.0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7.93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C57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.77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.73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540417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lc11a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.2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9E7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8.76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.55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.21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1C67C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ranspor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2573325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a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84.77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3.48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B67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.26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.89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0617867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ap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1.6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1.8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7D6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.6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.4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C27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9602276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apbp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05.84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77.83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37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.93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9.38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CF7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6231105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D27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1303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.74273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A07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9698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799817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D-L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1626739"/>
                  </a:ext>
                </a:extLst>
              </a:tr>
            </a:tbl>
          </a:graphicData>
        </a:graphic>
      </p:graphicFrame>
      <p:pic>
        <p:nvPicPr>
          <p:cNvPr id="5" name="Picture 4"/>
          <p:cNvPicPr/>
          <p:nvPr/>
        </p:nvPicPr>
        <p:blipFill>
          <a:blip r:embed="rId2"/>
          <a:stretch>
            <a:fillRect/>
          </a:stretch>
        </p:blipFill>
        <p:spPr>
          <a:xfrm>
            <a:off x="617855" y="6319837"/>
            <a:ext cx="4673600" cy="26765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08155" y="29008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08155" y="6169449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120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1 </a:t>
            </a:r>
          </a:p>
        </p:txBody>
      </p:sp>
    </p:spTree>
    <p:extLst>
      <p:ext uri="{BB962C8B-B14F-4D97-AF65-F5344CB8AC3E}">
        <p14:creationId xmlns:p14="http://schemas.microsoft.com/office/powerpoint/2010/main" val="22827092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793" y="314325"/>
            <a:ext cx="6577207" cy="882967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120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2 </a:t>
            </a:r>
          </a:p>
        </p:txBody>
      </p:sp>
    </p:spTree>
    <p:extLst>
      <p:ext uri="{BB962C8B-B14F-4D97-AF65-F5344CB8AC3E}">
        <p14:creationId xmlns:p14="http://schemas.microsoft.com/office/powerpoint/2010/main" val="7428190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1685721"/>
              </p:ext>
            </p:extLst>
          </p:nvPr>
        </p:nvGraphicFramePr>
        <p:xfrm>
          <a:off x="689643" y="4762831"/>
          <a:ext cx="2797748" cy="20969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966895" imgH="2973072" progId="Prism8.Document">
                  <p:embed/>
                </p:oleObj>
              </mc:Choice>
              <mc:Fallback>
                <p:oleObj name="Prism 8" r:id="rId2" imgW="3966895" imgH="2973072" progId="Prism8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89643" y="4762831"/>
                        <a:ext cx="2797748" cy="20969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3160981"/>
              </p:ext>
            </p:extLst>
          </p:nvPr>
        </p:nvGraphicFramePr>
        <p:xfrm>
          <a:off x="3162924" y="4636929"/>
          <a:ext cx="3294079" cy="23050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855613" imgH="2698634" progId="Prism8.Document">
                  <p:embed/>
                </p:oleObj>
              </mc:Choice>
              <mc:Fallback>
                <p:oleObj name="Prism 8" r:id="rId4" imgW="3855613" imgH="2698634" progId="Prism8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62924" y="4636929"/>
                        <a:ext cx="3294079" cy="23050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483972" y="6873907"/>
            <a:ext cx="5791656" cy="2074008"/>
            <a:chOff x="703509" y="782148"/>
            <a:chExt cx="5791656" cy="2039206"/>
          </a:xfrm>
        </p:grpSpPr>
        <p:graphicFrame>
          <p:nvGraphicFramePr>
            <p:cNvPr id="10" name="Object 9"/>
            <p:cNvGraphicFramePr>
              <a:graphicFrameLocks noChangeAspect="1"/>
            </p:cNvGraphicFramePr>
            <p:nvPr/>
          </p:nvGraphicFramePr>
          <p:xfrm>
            <a:off x="703509" y="782149"/>
            <a:ext cx="1361094" cy="20392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218436" imgH="3322061" progId="Prism8.Document">
                    <p:embed/>
                  </p:oleObj>
                </mc:Choice>
                <mc:Fallback>
                  <p:oleObj name="Prism 8" r:id="rId6" imgW="2218436" imgH="3322061" progId="Prism8.Document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03509" y="782149"/>
                          <a:ext cx="1361094" cy="20392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/>
            <p:cNvGraphicFramePr>
              <a:graphicFrameLocks noChangeAspect="1"/>
            </p:cNvGraphicFramePr>
            <p:nvPr/>
          </p:nvGraphicFramePr>
          <p:xfrm>
            <a:off x="1879235" y="787034"/>
            <a:ext cx="1311275" cy="2033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2144968" imgH="3322061" progId="Prism8.Document">
                    <p:embed/>
                  </p:oleObj>
                </mc:Choice>
                <mc:Fallback>
                  <p:oleObj name="Prism 8" r:id="rId8" imgW="2144968" imgH="3322061" progId="Prism8.Document">
                    <p:embed/>
                    <p:pic>
                      <p:nvPicPr>
                        <p:cNvPr id="11" name="Object 10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879235" y="787034"/>
                          <a:ext cx="1311275" cy="2033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82534517"/>
                </p:ext>
              </p:extLst>
            </p:nvPr>
          </p:nvGraphicFramePr>
          <p:xfrm>
            <a:off x="3002572" y="782271"/>
            <a:ext cx="1247775" cy="2038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035487" imgH="3322061" progId="Prism8.Document">
                    <p:embed/>
                  </p:oleObj>
                </mc:Choice>
                <mc:Fallback>
                  <p:oleObj name="Prism 8" r:id="rId10" imgW="2035487" imgH="3322061" progId="Prism8.Document">
                    <p:embed/>
                    <p:pic>
                      <p:nvPicPr>
                        <p:cNvPr id="12" name="Object 11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002572" y="782271"/>
                          <a:ext cx="1247775" cy="2038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/>
            <p:cNvGraphicFramePr>
              <a:graphicFrameLocks noChangeAspect="1"/>
            </p:cNvGraphicFramePr>
            <p:nvPr/>
          </p:nvGraphicFramePr>
          <p:xfrm>
            <a:off x="4151621" y="782271"/>
            <a:ext cx="1247775" cy="2038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035487" imgH="3322061" progId="Prism8.Document">
                    <p:embed/>
                  </p:oleObj>
                </mc:Choice>
                <mc:Fallback>
                  <p:oleObj name="Prism 8" r:id="rId12" imgW="2035487" imgH="3322061" progId="Prism8.Document">
                    <p:embed/>
                    <p:pic>
                      <p:nvPicPr>
                        <p:cNvPr id="13" name="Object 12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151621" y="782271"/>
                          <a:ext cx="1247775" cy="2038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/>
            <p:cNvGraphicFramePr>
              <a:graphicFrameLocks noChangeAspect="1"/>
            </p:cNvGraphicFramePr>
            <p:nvPr/>
          </p:nvGraphicFramePr>
          <p:xfrm>
            <a:off x="5293856" y="782148"/>
            <a:ext cx="1201309" cy="20392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1957698" imgH="3322061" progId="Prism8.Document">
                    <p:embed/>
                  </p:oleObj>
                </mc:Choice>
                <mc:Fallback>
                  <p:oleObj name="Prism 8" r:id="rId14" imgW="1957698" imgH="3322061" progId="Prism8.Document">
                    <p:embed/>
                    <p:pic>
                      <p:nvPicPr>
                        <p:cNvPr id="14" name="Object 13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293856" y="782148"/>
                          <a:ext cx="1201309" cy="20392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Rectangle 6"/>
          <p:cNvSpPr/>
          <p:nvPr/>
        </p:nvSpPr>
        <p:spPr>
          <a:xfrm>
            <a:off x="424555" y="369333"/>
            <a:ext cx="6069601" cy="85361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362915"/>
              </p:ext>
            </p:extLst>
          </p:nvPr>
        </p:nvGraphicFramePr>
        <p:xfrm>
          <a:off x="668938" y="2529989"/>
          <a:ext cx="2938991" cy="2206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948528" imgH="2964068" progId="Prism8.Document">
                  <p:embed/>
                </p:oleObj>
              </mc:Choice>
              <mc:Fallback>
                <p:oleObj name="Prism 8" r:id="rId16" imgW="3948528" imgH="2964068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68938" y="2529989"/>
                        <a:ext cx="2938991" cy="22063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5557546"/>
              </p:ext>
            </p:extLst>
          </p:nvPr>
        </p:nvGraphicFramePr>
        <p:xfrm>
          <a:off x="3107057" y="2413056"/>
          <a:ext cx="3486580" cy="244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855613" imgH="2698634" progId="Prism8.Document">
                  <p:embed/>
                </p:oleObj>
              </mc:Choice>
              <mc:Fallback>
                <p:oleObj name="Prism 8" r:id="rId18" imgW="3855613" imgH="2698634" progId="Prism8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107057" y="2413056"/>
                        <a:ext cx="3486580" cy="2440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0" y="0"/>
            <a:ext cx="120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3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93789FB-ABED-4686-ABFE-8522870A8E00}"/>
              </a:ext>
            </a:extLst>
          </p:cNvPr>
          <p:cNvSpPr txBox="1"/>
          <p:nvPr/>
        </p:nvSpPr>
        <p:spPr>
          <a:xfrm>
            <a:off x="424555" y="58352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80D72CE-3ACE-47FA-8828-088A96A31D98}"/>
              </a:ext>
            </a:extLst>
          </p:cNvPr>
          <p:cNvSpPr txBox="1"/>
          <p:nvPr/>
        </p:nvSpPr>
        <p:spPr>
          <a:xfrm>
            <a:off x="463594" y="683145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1880640"/>
              </p:ext>
            </p:extLst>
          </p:nvPr>
        </p:nvGraphicFramePr>
        <p:xfrm>
          <a:off x="709177" y="444791"/>
          <a:ext cx="2786841" cy="21331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3884784" imgH="2973072" progId="Prism8.Document">
                  <p:embed/>
                </p:oleObj>
              </mc:Choice>
              <mc:Fallback>
                <p:oleObj name="Prism 8" r:id="rId20" imgW="3884784" imgH="297307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709177" y="444791"/>
                        <a:ext cx="2786841" cy="21331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7514716"/>
              </p:ext>
            </p:extLst>
          </p:nvPr>
        </p:nvGraphicFramePr>
        <p:xfrm>
          <a:off x="3130831" y="374176"/>
          <a:ext cx="3189287" cy="2232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2" imgW="3855613" imgH="2698634" progId="Prism8.Document">
                  <p:embed/>
                </p:oleObj>
              </mc:Choice>
              <mc:Fallback>
                <p:oleObj name="Prism 8" r:id="rId22" imgW="3855613" imgH="26986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130831" y="374176"/>
                        <a:ext cx="3189287" cy="2232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883509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226" y="523875"/>
            <a:ext cx="6792774" cy="81438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120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4 </a:t>
            </a:r>
          </a:p>
        </p:txBody>
      </p:sp>
    </p:spTree>
    <p:extLst>
      <p:ext uri="{BB962C8B-B14F-4D97-AF65-F5344CB8AC3E}">
        <p14:creationId xmlns:p14="http://schemas.microsoft.com/office/powerpoint/2010/main" val="23112934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20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5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09625"/>
            <a:ext cx="6806175" cy="429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38346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24960"/>
            <a:ext cx="6752730" cy="628076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120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6 </a:t>
            </a:r>
          </a:p>
        </p:txBody>
      </p:sp>
    </p:spTree>
    <p:extLst>
      <p:ext uri="{BB962C8B-B14F-4D97-AF65-F5344CB8AC3E}">
        <p14:creationId xmlns:p14="http://schemas.microsoft.com/office/powerpoint/2010/main" val="4223277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3</TotalTime>
  <Words>484</Words>
  <Application>Microsoft Macintosh PowerPoint</Application>
  <PresentationFormat>Letter Paper (8.5x11 in)</PresentationFormat>
  <Paragraphs>402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shing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Michael</dc:creator>
  <cp:lastModifiedBy>Chen, Michael</cp:lastModifiedBy>
  <cp:revision>12</cp:revision>
  <dcterms:created xsi:type="dcterms:W3CDTF">2022-03-14T15:26:04Z</dcterms:created>
  <dcterms:modified xsi:type="dcterms:W3CDTF">2023-02-27T01:42:29Z</dcterms:modified>
</cp:coreProperties>
</file>